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56" r:id="rId4"/>
    <p:sldId id="263" r:id="rId5"/>
    <p:sldId id="258" r:id="rId6"/>
    <p:sldId id="269" r:id="rId7"/>
    <p:sldId id="265" r:id="rId8"/>
    <p:sldId id="264" r:id="rId9"/>
    <p:sldId id="268" r:id="rId10"/>
    <p:sldId id="266" r:id="rId11"/>
    <p:sldId id="257" r:id="rId12"/>
    <p:sldId id="259" r:id="rId13"/>
    <p:sldId id="260" r:id="rId14"/>
    <p:sldId id="270" r:id="rId1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6" d="100"/>
          <a:sy n="106" d="100"/>
        </p:scale>
        <p:origin x="-882" y="6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022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249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465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035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204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617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417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845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412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30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954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4F79FD-87DD-41B0-A9D6-71132CD7C4D7}" type="datetimeFigureOut">
              <a:rPr lang="en-US" smtClean="0"/>
              <a:t>11/1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0B9E11-ABA9-4D96-817A-A65046F9AA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926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9859" y="1524000"/>
            <a:ext cx="3194369" cy="4662488"/>
          </a:xfrm>
        </p:spPr>
      </p:pic>
      <p:sp>
        <p:nvSpPr>
          <p:cNvPr id="6" name="TextBox 5"/>
          <p:cNvSpPr txBox="1"/>
          <p:nvPr/>
        </p:nvSpPr>
        <p:spPr>
          <a:xfrm>
            <a:off x="1640541" y="990600"/>
            <a:ext cx="3505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S5. </a:t>
            </a:r>
            <a:r>
              <a:rPr lang="en-US" dirty="0" smtClean="0"/>
              <a:t>Original blots in figure 1.</a:t>
            </a:r>
            <a:endParaRPr lang="en-US" dirty="0"/>
          </a:p>
        </p:txBody>
      </p:sp>
      <p:pic>
        <p:nvPicPr>
          <p:cNvPr id="7" name="Content Placeholder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0541" y="6400800"/>
            <a:ext cx="3476417" cy="2468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688281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190262" y="1161369"/>
            <a:ext cx="4640580" cy="6432642"/>
          </a:xfrm>
          <a:prstGeom prst="rect">
            <a:avLst/>
          </a:prstGeom>
        </p:spPr>
      </p:pic>
      <p:cxnSp>
        <p:nvCxnSpPr>
          <p:cNvPr id="4" name="Straight Connector 3"/>
          <p:cNvCxnSpPr/>
          <p:nvPr/>
        </p:nvCxnSpPr>
        <p:spPr>
          <a:xfrm>
            <a:off x="2286000" y="3421387"/>
            <a:ext cx="38100" cy="1143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1120587" y="3761154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 DOX 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372035" y="3750838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OX </a:t>
            </a:r>
            <a:endParaRPr lang="en-US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2959223" y="4159623"/>
            <a:ext cx="533400" cy="0"/>
          </a:xfrm>
          <a:prstGeom prst="straightConnector1">
            <a:avLst/>
          </a:prstGeom>
          <a:ln w="28575"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743200" y="4177553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E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5602607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348341" y="-891141"/>
            <a:ext cx="5531225" cy="792310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406611" y="2133600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 DOX 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658059" y="2123284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OX </a:t>
            </a:r>
            <a:endParaRPr lang="en-US" dirty="0"/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3245247" y="2532069"/>
            <a:ext cx="533400" cy="0"/>
          </a:xfrm>
          <a:prstGeom prst="straightConnector1">
            <a:avLst/>
          </a:prstGeom>
          <a:ln w="28575"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029224" y="2549999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APDH</a:t>
            </a:r>
            <a:endParaRPr lang="en-US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2571774" y="2143917"/>
            <a:ext cx="38100" cy="1143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968188" y="914400"/>
            <a:ext cx="1447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VAVAVAVA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62645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236600" y="-1209706"/>
            <a:ext cx="5764306" cy="823750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3200" y="1927410"/>
            <a:ext cx="4114800" cy="6206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500024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990600"/>
            <a:ext cx="4724400" cy="65917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194534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7847" y="914400"/>
            <a:ext cx="5002306" cy="7790049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>
            <a:off x="5231780" y="4154250"/>
            <a:ext cx="533400" cy="0"/>
          </a:xfrm>
          <a:prstGeom prst="straightConnector1">
            <a:avLst/>
          </a:prstGeom>
          <a:ln w="28575"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6020671" y="3962400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04684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1940" y="914400"/>
            <a:ext cx="4414120" cy="6477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69538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799" y="317682"/>
            <a:ext cx="5257457" cy="384283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256" y="4419600"/>
            <a:ext cx="5334000" cy="3842838"/>
          </a:xfrm>
          <a:prstGeom prst="rect">
            <a:avLst/>
          </a:prstGeom>
        </p:spPr>
      </p:pic>
      <p:cxnSp>
        <p:nvCxnSpPr>
          <p:cNvPr id="8" name="Straight Arrow Connector 7"/>
          <p:cNvCxnSpPr/>
          <p:nvPr/>
        </p:nvCxnSpPr>
        <p:spPr>
          <a:xfrm>
            <a:off x="5567952" y="2026912"/>
            <a:ext cx="533400" cy="0"/>
          </a:xfrm>
          <a:prstGeom prst="straightConnector1">
            <a:avLst/>
          </a:prstGeom>
          <a:ln w="28575"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791200" y="1992868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97840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8540" y="914400"/>
            <a:ext cx="4710363" cy="30082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34857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653805"/>
            <a:ext cx="5486400" cy="7836390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2743200" y="1752600"/>
            <a:ext cx="38100" cy="1143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26639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Content Placeholder 7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852" y="2514600"/>
            <a:ext cx="5332295" cy="3488921"/>
          </a:xfrm>
        </p:spPr>
      </p:pic>
    </p:spTree>
    <p:extLst>
      <p:ext uri="{BB962C8B-B14F-4D97-AF65-F5344CB8AC3E}">
        <p14:creationId xmlns:p14="http://schemas.microsoft.com/office/powerpoint/2010/main" val="23772511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95000" y="4676187"/>
            <a:ext cx="7047999" cy="441588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3447" y="180416"/>
            <a:ext cx="7047998" cy="4400549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>
            <a:off x="3276600" y="688041"/>
            <a:ext cx="38100" cy="1143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828800" y="503375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 DOX 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510552" y="533400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OX 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28600" y="315578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eart</a:t>
            </a:r>
            <a:endParaRPr lang="en-US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4043952" y="1345595"/>
            <a:ext cx="533400" cy="0"/>
          </a:xfrm>
          <a:prstGeom prst="straightConnector1">
            <a:avLst/>
          </a:prstGeom>
          <a:ln w="28575"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800600" y="1259541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71712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740973" y="1737769"/>
            <a:ext cx="5894399" cy="8057662"/>
          </a:xfrm>
          <a:prstGeom prst="rect">
            <a:avLst/>
          </a:prstGeom>
        </p:spPr>
      </p:pic>
      <p:cxnSp>
        <p:nvCxnSpPr>
          <p:cNvPr id="5" name="Straight Connector 4"/>
          <p:cNvCxnSpPr/>
          <p:nvPr/>
        </p:nvCxnSpPr>
        <p:spPr>
          <a:xfrm>
            <a:off x="5674659" y="2613209"/>
            <a:ext cx="38100" cy="114300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226859" y="2428543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 DOX 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908611" y="2458568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OX </a:t>
            </a:r>
            <a:endParaRPr lang="en-US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6401670" y="3432127"/>
            <a:ext cx="533400" cy="0"/>
          </a:xfrm>
          <a:prstGeom prst="straightConnector1">
            <a:avLst/>
          </a:prstGeom>
          <a:ln w="28575"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6988858" y="3247461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-ER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40062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992467" y="1190440"/>
            <a:ext cx="5625358" cy="76640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8858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</TotalTime>
  <Words>28</Words>
  <Application>Microsoft Office PowerPoint</Application>
  <PresentationFormat>On-screen Show (4:3)</PresentationFormat>
  <Paragraphs>17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CS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h, Che-Chung</dc:creator>
  <cp:lastModifiedBy>Calumpang, Mario Jade</cp:lastModifiedBy>
  <cp:revision>23</cp:revision>
  <dcterms:created xsi:type="dcterms:W3CDTF">2016-09-26T20:18:21Z</dcterms:created>
  <dcterms:modified xsi:type="dcterms:W3CDTF">2017-11-16T13:15:28Z</dcterms:modified>
</cp:coreProperties>
</file>